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315200" cy="960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142880" y="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257120" y="720360"/>
            <a:ext cx="4800600" cy="3600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12024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14288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b">
            <a:noAutofit/>
          </a:bodyPr>
          <a:lstStyle>
            <a:lvl1pPr indent="0" algn="r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  <a:defRPr b="0" lang="en-US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594E3EB3-0606-4EC1-B0DD-D1C3066BC1E2}" type="slidenum">
              <a:rPr b="0" lang="en-US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Rectangle 7"/>
          <p:cNvSpPr/>
          <p:nvPr/>
        </p:nvSpPr>
        <p:spPr>
          <a:xfrm>
            <a:off x="414324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840" rIns="9684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FA3AE56C-75D7-4540-925F-73C3B8723D16}" type="slidenum">
              <a:rPr b="0" lang="en-US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1"/>
          <p:cNvSpPr>
            <a:spLocks noGrp="1"/>
          </p:cNvSpPr>
          <p:nvPr>
            <p:ph type="sldImg"/>
          </p:nvPr>
        </p:nvSpPr>
        <p:spPr>
          <a:xfrm>
            <a:off x="1257480" y="72072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20E380-0E13-45EB-AEE6-163598C0D07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5D66D0-AAB1-45C8-86CC-D226817597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14E5C5-7726-41D9-B572-B7EFBC3B62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A0A77B-17B4-4C6C-ADA9-BF5B7467D4E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9CFBD7-ABF5-4666-92A5-F37CE7C303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9D2B3E-B886-4DA4-820A-3205F00615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C34C32-35E9-48CF-9190-34935D7D15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06D32B-6140-4C07-A59A-08936B5B41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F6FFAB-507F-41CF-8C60-D191DBFBEA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852F07-89E0-4C2E-8B9D-6F15AB7407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13E574-E15A-422E-8A67-F39BA89480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CA9BBC-688E-41E4-9F25-143D20E9B1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2902EF3-33AE-404E-9503-9A99F298DC7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"/>
          <p:cNvGrpSpPr/>
          <p:nvPr/>
        </p:nvGrpSpPr>
        <p:grpSpPr>
          <a:xfrm>
            <a:off x="0" y="76320"/>
            <a:ext cx="9144000" cy="6722280"/>
            <a:chOff x="0" y="76320"/>
            <a:chExt cx="9144000" cy="6722280"/>
          </a:xfrm>
        </p:grpSpPr>
        <p:sp>
          <p:nvSpPr>
            <p:cNvPr id="49" name="Text Box 5"/>
            <p:cNvSpPr/>
            <p:nvPr/>
          </p:nvSpPr>
          <p:spPr>
            <a:xfrm>
              <a:off x="0" y="76320"/>
              <a:ext cx="3048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Figure S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Picture 6" descr=""/>
            <p:cNvPicPr/>
            <p:nvPr/>
          </p:nvPicPr>
          <p:blipFill>
            <a:blip r:embed="rId1"/>
            <a:stretch/>
          </p:blipFill>
          <p:spPr>
            <a:xfrm>
              <a:off x="4800600" y="407880"/>
              <a:ext cx="2017800" cy="2030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Text Box 7"/>
            <p:cNvSpPr/>
            <p:nvPr/>
          </p:nvSpPr>
          <p:spPr>
            <a:xfrm>
              <a:off x="685800" y="2575080"/>
              <a:ext cx="259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etabolism sub-networ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8"/>
            <p:cNvSpPr/>
            <p:nvPr/>
          </p:nvSpPr>
          <p:spPr>
            <a:xfrm>
              <a:off x="4495680" y="2514600"/>
              <a:ext cx="259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nflammation sub-networ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9"/>
            <p:cNvSpPr/>
            <p:nvPr/>
          </p:nvSpPr>
          <p:spPr>
            <a:xfrm>
              <a:off x="2743200" y="5334120"/>
              <a:ext cx="281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artilage homeostasis sub-networ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10"/>
            <p:cNvSpPr/>
            <p:nvPr/>
          </p:nvSpPr>
          <p:spPr>
            <a:xfrm>
              <a:off x="0" y="5638680"/>
              <a:ext cx="9144000" cy="115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igure S3.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he interactome network consists of 3 sub-networks.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(A) This sub-network (p=2.31x10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-12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) consists of proteins such as LEP (leptin), resistin (RETN), adiponectin (ADIPOQ), peroxisome proliferator activated receptor alpha (PPARA)  involved in metabolic pathways. (B) The second sub-network (p=4.77x10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-8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) consists of interleukins (IL1R, IL6, IL10) known to be involved in inflammatory pathways. (C) The third and largest sub-network (p=1.07x10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-6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) consists of cartilage structure proteins such as collagen II (COL2A1) and aggrecan (ACAN) and enzymes such as metalloproteinases 3 and 13 (MMP3, MMP13) and aggrecanases (ADAMTS4, ADAMTS5) that cleave cartilage structure proteins. The statistical test used to calculate the significance of the identified sub-networks indexes each real sub-network score on a local null distribution estimated from the scores of 100 random subnetworks initialized from the same seed protein as the real subnetwork. Significant sub-networks were selected if p&lt;0.001.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11"/>
            <p:cNvSpPr/>
            <p:nvPr/>
          </p:nvSpPr>
          <p:spPr>
            <a:xfrm>
              <a:off x="533520" y="609480"/>
              <a:ext cx="380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12"/>
            <p:cNvSpPr/>
            <p:nvPr/>
          </p:nvSpPr>
          <p:spPr>
            <a:xfrm>
              <a:off x="4648320" y="609480"/>
              <a:ext cx="380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13"/>
            <p:cNvSpPr/>
            <p:nvPr/>
          </p:nvSpPr>
          <p:spPr>
            <a:xfrm>
              <a:off x="2133720" y="2971800"/>
              <a:ext cx="380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8" name="Picture 4" descr=""/>
            <p:cNvPicPr/>
            <p:nvPr/>
          </p:nvPicPr>
          <p:blipFill>
            <a:blip r:embed="rId2"/>
            <a:stretch/>
          </p:blipFill>
          <p:spPr>
            <a:xfrm>
              <a:off x="2666880" y="2724120"/>
              <a:ext cx="3370320" cy="2660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Picture 3" descr=""/>
            <p:cNvPicPr/>
            <p:nvPr/>
          </p:nvPicPr>
          <p:blipFill>
            <a:blip r:embed="rId3"/>
            <a:stretch/>
          </p:blipFill>
          <p:spPr>
            <a:xfrm>
              <a:off x="1066680" y="76320"/>
              <a:ext cx="2044800" cy="27144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Dimitrios</cp:lastModifiedBy>
  <dcterms:modified xsi:type="dcterms:W3CDTF">2008-10-31T02:31:56Z</dcterms:modified>
  <cp:revision>5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